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15F4687-161C-438A-8F5B-B528AE3661AD}" v="20" dt="2022-12-12T14:43:54.554"/>
    <p1510:client id="{74601482-AC63-474E-8AA6-856375FC4BC4}" v="2" dt="2022-12-12T14:42:42.483"/>
    <p1510:client id="{BDBD81C3-986C-4B6C-8A6D-8D04053F6BE1}" v="5" dt="2022-12-19T08:40:51.16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1" d="100"/>
          <a:sy n="101" d="100"/>
        </p:scale>
        <p:origin x="29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laire Beraud" userId="S::claire.beraud@urosphere.com::88d8f020-165f-4369-a606-bc2a6e18c31d" providerId="AD" clId="Web-{BDBD81C3-986C-4B6C-8A6D-8D04053F6BE1}"/>
    <pc:docChg chg="modSld">
      <pc:chgData name="Claire Beraud" userId="S::claire.beraud@urosphere.com::88d8f020-165f-4369-a606-bc2a6e18c31d" providerId="AD" clId="Web-{BDBD81C3-986C-4B6C-8A6D-8D04053F6BE1}" dt="2022-12-19T08:40:51.161" v="2" actId="20577"/>
      <pc:docMkLst>
        <pc:docMk/>
      </pc:docMkLst>
      <pc:sldChg chg="delSp modSp">
        <pc:chgData name="Claire Beraud" userId="S::claire.beraud@urosphere.com::88d8f020-165f-4369-a606-bc2a6e18c31d" providerId="AD" clId="Web-{BDBD81C3-986C-4B6C-8A6D-8D04053F6BE1}" dt="2022-12-19T08:40:51.161" v="2" actId="20577"/>
        <pc:sldMkLst>
          <pc:docMk/>
          <pc:sldMk cId="485805771" sldId="256"/>
        </pc:sldMkLst>
        <pc:spChg chg="del">
          <ac:chgData name="Claire Beraud" userId="S::claire.beraud@urosphere.com::88d8f020-165f-4369-a606-bc2a6e18c31d" providerId="AD" clId="Web-{BDBD81C3-986C-4B6C-8A6D-8D04053F6BE1}" dt="2022-12-19T08:39:43.097" v="0"/>
          <ac:spMkLst>
            <pc:docMk/>
            <pc:sldMk cId="485805771" sldId="256"/>
            <ac:spMk id="2" creationId="{BF7D6AF3-FD61-8E71-4269-B661AFE549FE}"/>
          </ac:spMkLst>
        </pc:spChg>
        <pc:spChg chg="mod">
          <ac:chgData name="Claire Beraud" userId="S::claire.beraud@urosphere.com::88d8f020-165f-4369-a606-bc2a6e18c31d" providerId="AD" clId="Web-{BDBD81C3-986C-4B6C-8A6D-8D04053F6BE1}" dt="2022-12-19T08:40:51.161" v="2" actId="20577"/>
          <ac:spMkLst>
            <pc:docMk/>
            <pc:sldMk cId="485805771" sldId="256"/>
            <ac:spMk id="8" creationId="{00000000-0000-0000-0000-000000000000}"/>
          </ac:spMkLst>
        </pc:spChg>
      </pc:sldChg>
    </pc:docChg>
  </pc:docChgLst>
  <pc:docChgLst>
    <pc:chgData name="Claire Beraud" userId="S::claire.beraud@urosphere.com::88d8f020-165f-4369-a606-bc2a6e18c31d" providerId="AD" clId="Web-{74601482-AC63-474E-8AA6-856375FC4BC4}"/>
    <pc:docChg chg="modSld">
      <pc:chgData name="Claire Beraud" userId="S::claire.beraud@urosphere.com::88d8f020-165f-4369-a606-bc2a6e18c31d" providerId="AD" clId="Web-{74601482-AC63-474E-8AA6-856375FC4BC4}" dt="2022-12-12T14:42:42.483" v="1"/>
      <pc:docMkLst>
        <pc:docMk/>
      </pc:docMkLst>
      <pc:sldChg chg="addSp modSp">
        <pc:chgData name="Claire Beraud" userId="S::claire.beraud@urosphere.com::88d8f020-165f-4369-a606-bc2a6e18c31d" providerId="AD" clId="Web-{74601482-AC63-474E-8AA6-856375FC4BC4}" dt="2022-12-12T14:42:42.483" v="1"/>
        <pc:sldMkLst>
          <pc:docMk/>
          <pc:sldMk cId="485805771" sldId="256"/>
        </pc:sldMkLst>
        <pc:spChg chg="add mod">
          <ac:chgData name="Claire Beraud" userId="S::claire.beraud@urosphere.com::88d8f020-165f-4369-a606-bc2a6e18c31d" providerId="AD" clId="Web-{74601482-AC63-474E-8AA6-856375FC4BC4}" dt="2022-12-12T14:42:42.483" v="1"/>
          <ac:spMkLst>
            <pc:docMk/>
            <pc:sldMk cId="485805771" sldId="256"/>
            <ac:spMk id="2" creationId="{BF7D6AF3-FD61-8E71-4269-B661AFE549FE}"/>
          </ac:spMkLst>
        </pc:spChg>
      </pc:sldChg>
    </pc:docChg>
  </pc:docChgLst>
  <pc:docChgLst>
    <pc:chgData name="Claire Beraud" userId="S::claire.beraud@urosphere.com::88d8f020-165f-4369-a606-bc2a6e18c31d" providerId="AD" clId="Web-{015F4687-161C-438A-8F5B-B528AE3661AD}"/>
    <pc:docChg chg="modSld">
      <pc:chgData name="Claire Beraud" userId="S::claire.beraud@urosphere.com::88d8f020-165f-4369-a606-bc2a6e18c31d" providerId="AD" clId="Web-{015F4687-161C-438A-8F5B-B528AE3661AD}" dt="2022-12-12T14:43:53.226" v="9" actId="20577"/>
      <pc:docMkLst>
        <pc:docMk/>
      </pc:docMkLst>
      <pc:sldChg chg="modSp">
        <pc:chgData name="Claire Beraud" userId="S::claire.beraud@urosphere.com::88d8f020-165f-4369-a606-bc2a6e18c31d" providerId="AD" clId="Web-{015F4687-161C-438A-8F5B-B528AE3661AD}" dt="2022-12-12T14:43:53.226" v="9" actId="20577"/>
        <pc:sldMkLst>
          <pc:docMk/>
          <pc:sldMk cId="485805771" sldId="256"/>
        </pc:sldMkLst>
        <pc:spChg chg="mod">
          <ac:chgData name="Claire Beraud" userId="S::claire.beraud@urosphere.com::88d8f020-165f-4369-a606-bc2a6e18c31d" providerId="AD" clId="Web-{015F4687-161C-438A-8F5B-B528AE3661AD}" dt="2022-12-12T14:43:53.226" v="9" actId="20577"/>
          <ac:spMkLst>
            <pc:docMk/>
            <pc:sldMk cId="485805771" sldId="256"/>
            <ac:spMk id="2" creationId="{BF7D6AF3-FD61-8E71-4269-B661AFE549FE}"/>
          </ac:spMkLst>
        </pc:spChg>
      </pc:sldChg>
    </pc:docChg>
  </pc:docChgLst>
  <pc:docChgLst>
    <pc:chgData name="Nadege" userId="101290c6-d7fd-4e4f-abb4-82cb3a45689d" providerId="ADAL" clId="{071AA966-F75F-4491-9BF3-35716F3A2D7F}"/>
    <pc:docChg chg="modSld">
      <pc:chgData name="Nadege" userId="101290c6-d7fd-4e4f-abb4-82cb3a45689d" providerId="ADAL" clId="{071AA966-F75F-4491-9BF3-35716F3A2D7F}" dt="2022-12-08T09:24:41.230" v="15" actId="1037"/>
      <pc:docMkLst>
        <pc:docMk/>
      </pc:docMkLst>
      <pc:sldChg chg="modSp mod">
        <pc:chgData name="Nadege" userId="101290c6-d7fd-4e4f-abb4-82cb3a45689d" providerId="ADAL" clId="{071AA966-F75F-4491-9BF3-35716F3A2D7F}" dt="2022-12-08T09:24:41.230" v="15" actId="1037"/>
        <pc:sldMkLst>
          <pc:docMk/>
          <pc:sldMk cId="485805771" sldId="256"/>
        </pc:sldMkLst>
        <pc:spChg chg="mod">
          <ac:chgData name="Nadege" userId="101290c6-d7fd-4e4f-abb4-82cb3a45689d" providerId="ADAL" clId="{071AA966-F75F-4491-9BF3-35716F3A2D7F}" dt="2022-12-08T09:24:15.076" v="0" actId="2711"/>
          <ac:spMkLst>
            <pc:docMk/>
            <pc:sldMk cId="485805771" sldId="256"/>
            <ac:spMk id="4" creationId="{00000000-0000-0000-0000-000000000000}"/>
          </ac:spMkLst>
        </pc:spChg>
        <pc:spChg chg="mod">
          <ac:chgData name="Nadege" userId="101290c6-d7fd-4e4f-abb4-82cb3a45689d" providerId="ADAL" clId="{071AA966-F75F-4491-9BF3-35716F3A2D7F}" dt="2022-12-08T09:24:15.076" v="0" actId="2711"/>
          <ac:spMkLst>
            <pc:docMk/>
            <pc:sldMk cId="485805771" sldId="256"/>
            <ac:spMk id="5" creationId="{00000000-0000-0000-0000-000000000000}"/>
          </ac:spMkLst>
        </pc:spChg>
        <pc:spChg chg="mod">
          <ac:chgData name="Nadege" userId="101290c6-d7fd-4e4f-abb4-82cb3a45689d" providerId="ADAL" clId="{071AA966-F75F-4491-9BF3-35716F3A2D7F}" dt="2022-12-08T09:24:15.076" v="0" actId="2711"/>
          <ac:spMkLst>
            <pc:docMk/>
            <pc:sldMk cId="485805771" sldId="256"/>
            <ac:spMk id="6" creationId="{00000000-0000-0000-0000-000000000000}"/>
          </ac:spMkLst>
        </pc:spChg>
        <pc:spChg chg="mod">
          <ac:chgData name="Nadege" userId="101290c6-d7fd-4e4f-abb4-82cb3a45689d" providerId="ADAL" clId="{071AA966-F75F-4491-9BF3-35716F3A2D7F}" dt="2022-12-08T09:24:15.076" v="0" actId="2711"/>
          <ac:spMkLst>
            <pc:docMk/>
            <pc:sldMk cId="485805771" sldId="256"/>
            <ac:spMk id="7" creationId="{00000000-0000-0000-0000-000000000000}"/>
          </ac:spMkLst>
        </pc:spChg>
        <pc:spChg chg="mod">
          <ac:chgData name="Nadege" userId="101290c6-d7fd-4e4f-abb4-82cb3a45689d" providerId="ADAL" clId="{071AA966-F75F-4491-9BF3-35716F3A2D7F}" dt="2022-12-08T09:24:27.275" v="1" actId="14100"/>
          <ac:spMkLst>
            <pc:docMk/>
            <pc:sldMk cId="485805771" sldId="256"/>
            <ac:spMk id="8" creationId="{00000000-0000-0000-0000-000000000000}"/>
          </ac:spMkLst>
        </pc:spChg>
        <pc:spChg chg="mod">
          <ac:chgData name="Nadege" userId="101290c6-d7fd-4e4f-abb4-82cb3a45689d" providerId="ADAL" clId="{071AA966-F75F-4491-9BF3-35716F3A2D7F}" dt="2022-12-08T09:24:15.076" v="0" actId="2711"/>
          <ac:spMkLst>
            <pc:docMk/>
            <pc:sldMk cId="485805771" sldId="256"/>
            <ac:spMk id="12" creationId="{00000000-0000-0000-0000-000000000000}"/>
          </ac:spMkLst>
        </pc:spChg>
        <pc:spChg chg="mod">
          <ac:chgData name="Nadege" userId="101290c6-d7fd-4e4f-abb4-82cb3a45689d" providerId="ADAL" clId="{071AA966-F75F-4491-9BF3-35716F3A2D7F}" dt="2022-12-08T09:24:41.230" v="15" actId="1037"/>
          <ac:spMkLst>
            <pc:docMk/>
            <pc:sldMk cId="485805771" sldId="256"/>
            <ac:spMk id="13" creationId="{00000000-0000-0000-0000-000000000000}"/>
          </ac:spMkLst>
        </pc:spChg>
        <pc:spChg chg="mod">
          <ac:chgData name="Nadege" userId="101290c6-d7fd-4e4f-abb4-82cb3a45689d" providerId="ADAL" clId="{071AA966-F75F-4491-9BF3-35716F3A2D7F}" dt="2022-12-08T09:24:41.230" v="15" actId="1037"/>
          <ac:spMkLst>
            <pc:docMk/>
            <pc:sldMk cId="485805771" sldId="256"/>
            <ac:spMk id="14" creationId="{00000000-0000-0000-0000-000000000000}"/>
          </ac:spMkLst>
        </pc:spChg>
        <pc:spChg chg="mod">
          <ac:chgData name="Nadege" userId="101290c6-d7fd-4e4f-abb4-82cb3a45689d" providerId="ADAL" clId="{071AA966-F75F-4491-9BF3-35716F3A2D7F}" dt="2022-12-08T09:24:15.076" v="0" actId="2711"/>
          <ac:spMkLst>
            <pc:docMk/>
            <pc:sldMk cId="485805771" sldId="256"/>
            <ac:spMk id="15" creationId="{00000000-0000-0000-0000-000000000000}"/>
          </ac:spMkLst>
        </pc:spChg>
        <pc:spChg chg="mod">
          <ac:chgData name="Nadege" userId="101290c6-d7fd-4e4f-abb4-82cb3a45689d" providerId="ADAL" clId="{071AA966-F75F-4491-9BF3-35716F3A2D7F}" dt="2022-12-08T09:24:41.230" v="15" actId="1037"/>
          <ac:spMkLst>
            <pc:docMk/>
            <pc:sldMk cId="485805771" sldId="256"/>
            <ac:spMk id="16" creationId="{E6632EA9-DD55-4DA4-AC0B-E3E13D6B57E6}"/>
          </ac:spMkLst>
        </pc:spChg>
        <pc:spChg chg="mod">
          <ac:chgData name="Nadege" userId="101290c6-d7fd-4e4f-abb4-82cb3a45689d" providerId="ADAL" clId="{071AA966-F75F-4491-9BF3-35716F3A2D7F}" dt="2022-12-08T09:24:15.076" v="0" actId="2711"/>
          <ac:spMkLst>
            <pc:docMk/>
            <pc:sldMk cId="485805771" sldId="256"/>
            <ac:spMk id="17" creationId="{39DA79F4-7AFB-C141-944B-4484E231B8F3}"/>
          </ac:spMkLst>
        </pc:spChg>
        <pc:spChg chg="mod">
          <ac:chgData name="Nadege" userId="101290c6-d7fd-4e4f-abb4-82cb3a45689d" providerId="ADAL" clId="{071AA966-F75F-4491-9BF3-35716F3A2D7F}" dt="2022-12-08T09:24:15.076" v="0" actId="2711"/>
          <ac:spMkLst>
            <pc:docMk/>
            <pc:sldMk cId="485805771" sldId="256"/>
            <ac:spMk id="18" creationId="{57DE582E-934C-3748-B767-0C35E72BF1D2}"/>
          </ac:spMkLst>
        </pc:spChg>
        <pc:spChg chg="mod">
          <ac:chgData name="Nadege" userId="101290c6-d7fd-4e4f-abb4-82cb3a45689d" providerId="ADAL" clId="{071AA966-F75F-4491-9BF3-35716F3A2D7F}" dt="2022-12-08T09:24:15.076" v="0" actId="2711"/>
          <ac:spMkLst>
            <pc:docMk/>
            <pc:sldMk cId="485805771" sldId="256"/>
            <ac:spMk id="19" creationId="{2E2FDCBA-F211-4045-8D87-F2FF6A0E9236}"/>
          </ac:spMkLst>
        </pc:spChg>
        <pc:spChg chg="mod">
          <ac:chgData name="Nadege" userId="101290c6-d7fd-4e4f-abb4-82cb3a45689d" providerId="ADAL" clId="{071AA966-F75F-4491-9BF3-35716F3A2D7F}" dt="2022-12-08T09:24:15.076" v="0" actId="2711"/>
          <ac:spMkLst>
            <pc:docMk/>
            <pc:sldMk cId="485805771" sldId="256"/>
            <ac:spMk id="20" creationId="{6EFC10A4-2C14-114F-9A26-351313039928}"/>
          </ac:spMkLst>
        </pc:spChg>
        <pc:spChg chg="mod">
          <ac:chgData name="Nadege" userId="101290c6-d7fd-4e4f-abb4-82cb3a45689d" providerId="ADAL" clId="{071AA966-F75F-4491-9BF3-35716F3A2D7F}" dt="2022-12-08T09:24:15.076" v="0" actId="2711"/>
          <ac:spMkLst>
            <pc:docMk/>
            <pc:sldMk cId="485805771" sldId="256"/>
            <ac:spMk id="21" creationId="{00000000-0000-0000-0000-000000000000}"/>
          </ac:spMkLst>
        </pc:spChg>
      </pc:sldChg>
    </pc:docChg>
  </pc:docChgLst>
  <pc:docChgLst>
    <pc:chgData name="Yolande Misseri" userId="S::yolande.misseri@urosphere.com::ef38e326-f0d7-464f-a7bc-a259d337bc92" providerId="AD" clId="Web-{97B9AA11-A38C-45C1-98AC-E640C481955E}"/>
    <pc:docChg chg="addSld delSld modSld">
      <pc:chgData name="Yolande Misseri" userId="S::yolande.misseri@urosphere.com::ef38e326-f0d7-464f-a7bc-a259d337bc92" providerId="AD" clId="Web-{97B9AA11-A38C-45C1-98AC-E640C481955E}" dt="2022-10-25T15:25:18.225" v="43"/>
      <pc:docMkLst>
        <pc:docMk/>
      </pc:docMkLst>
      <pc:sldChg chg="modSp">
        <pc:chgData name="Yolande Misseri" userId="S::yolande.misseri@urosphere.com::ef38e326-f0d7-464f-a7bc-a259d337bc92" providerId="AD" clId="Web-{97B9AA11-A38C-45C1-98AC-E640C481955E}" dt="2022-10-25T15:23:15.456" v="41" actId="20577"/>
        <pc:sldMkLst>
          <pc:docMk/>
          <pc:sldMk cId="485805771" sldId="256"/>
        </pc:sldMkLst>
        <pc:spChg chg="mod">
          <ac:chgData name="Yolande Misseri" userId="S::yolande.misseri@urosphere.com::ef38e326-f0d7-464f-a7bc-a259d337bc92" providerId="AD" clId="Web-{97B9AA11-A38C-45C1-98AC-E640C481955E}" dt="2022-10-25T15:21:57.676" v="34" actId="1076"/>
          <ac:spMkLst>
            <pc:docMk/>
            <pc:sldMk cId="485805771" sldId="256"/>
            <ac:spMk id="6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97B9AA11-A38C-45C1-98AC-E640C481955E}" dt="2022-10-25T15:22:00.564" v="35" actId="14100"/>
          <ac:spMkLst>
            <pc:docMk/>
            <pc:sldMk cId="485805771" sldId="256"/>
            <ac:spMk id="8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97B9AA11-A38C-45C1-98AC-E640C481955E}" dt="2022-10-25T15:21:10.891" v="6" actId="1076"/>
          <ac:spMkLst>
            <pc:docMk/>
            <pc:sldMk cId="485805771" sldId="256"/>
            <ac:spMk id="13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97B9AA11-A38C-45C1-98AC-E640C481955E}" dt="2022-10-25T15:23:15.456" v="41" actId="20577"/>
          <ac:spMkLst>
            <pc:docMk/>
            <pc:sldMk cId="485805771" sldId="256"/>
            <ac:spMk id="15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97B9AA11-A38C-45C1-98AC-E640C481955E}" dt="2022-10-25T15:21:42.001" v="30" actId="20577"/>
          <ac:spMkLst>
            <pc:docMk/>
            <pc:sldMk cId="485805771" sldId="256"/>
            <ac:spMk id="16" creationId="{E6632EA9-DD55-4DA4-AC0B-E3E13D6B57E6}"/>
          </ac:spMkLst>
        </pc:spChg>
        <pc:spChg chg="mod">
          <ac:chgData name="Yolande Misseri" userId="S::yolande.misseri@urosphere.com::ef38e326-f0d7-464f-a7bc-a259d337bc92" providerId="AD" clId="Web-{97B9AA11-A38C-45C1-98AC-E640C481955E}" dt="2022-10-25T15:21:57.658" v="33" actId="1076"/>
          <ac:spMkLst>
            <pc:docMk/>
            <pc:sldMk cId="485805771" sldId="256"/>
            <ac:spMk id="19" creationId="{2E2FDCBA-F211-4045-8D87-F2FF6A0E9236}"/>
          </ac:spMkLst>
        </pc:spChg>
        <pc:cxnChg chg="mod">
          <ac:chgData name="Yolande Misseri" userId="S::yolande.misseri@urosphere.com::ef38e326-f0d7-464f-a7bc-a259d337bc92" providerId="AD" clId="Web-{97B9AA11-A38C-45C1-98AC-E640C481955E}" dt="2022-10-25T15:22:11.299" v="37" actId="14100"/>
          <ac:cxnSpMkLst>
            <pc:docMk/>
            <pc:sldMk cId="485805771" sldId="256"/>
            <ac:cxnSpMk id="11" creationId="{00000000-0000-0000-0000-000000000000}"/>
          </ac:cxnSpMkLst>
        </pc:cxnChg>
      </pc:sldChg>
      <pc:sldChg chg="new del">
        <pc:chgData name="Yolande Misseri" userId="S::yolande.misseri@urosphere.com::ef38e326-f0d7-464f-a7bc-a259d337bc92" providerId="AD" clId="Web-{97B9AA11-A38C-45C1-98AC-E640C481955E}" dt="2022-10-25T15:25:18.225" v="43"/>
        <pc:sldMkLst>
          <pc:docMk/>
          <pc:sldMk cId="2799997074" sldId="25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38DCF-C78E-4340-AFD1-1E466CC03A53}" type="datetimeFigureOut">
              <a:rPr lang="fr-FR" smtClean="0"/>
              <a:t>24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79BC1-A1AE-4AD4-A9A6-260F0C11FC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4986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38DCF-C78E-4340-AFD1-1E466CC03A53}" type="datetimeFigureOut">
              <a:rPr lang="fr-FR" smtClean="0"/>
              <a:t>24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79BC1-A1AE-4AD4-A9A6-260F0C11FC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841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38DCF-C78E-4340-AFD1-1E466CC03A53}" type="datetimeFigureOut">
              <a:rPr lang="fr-FR" smtClean="0"/>
              <a:t>24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79BC1-A1AE-4AD4-A9A6-260F0C11FC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1520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38DCF-C78E-4340-AFD1-1E466CC03A53}" type="datetimeFigureOut">
              <a:rPr lang="fr-FR" smtClean="0"/>
              <a:t>24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79BC1-A1AE-4AD4-A9A6-260F0C11FC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0117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38DCF-C78E-4340-AFD1-1E466CC03A53}" type="datetimeFigureOut">
              <a:rPr lang="fr-FR" smtClean="0"/>
              <a:t>24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79BC1-A1AE-4AD4-A9A6-260F0C11FC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96547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38DCF-C78E-4340-AFD1-1E466CC03A53}" type="datetimeFigureOut">
              <a:rPr lang="fr-FR" smtClean="0"/>
              <a:t>24/0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79BC1-A1AE-4AD4-A9A6-260F0C11FC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9641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38DCF-C78E-4340-AFD1-1E466CC03A53}" type="datetimeFigureOut">
              <a:rPr lang="fr-FR" smtClean="0"/>
              <a:t>24/02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79BC1-A1AE-4AD4-A9A6-260F0C11FC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26889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38DCF-C78E-4340-AFD1-1E466CC03A53}" type="datetimeFigureOut">
              <a:rPr lang="fr-FR" smtClean="0"/>
              <a:t>24/02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79BC1-A1AE-4AD4-A9A6-260F0C11FC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4223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38DCF-C78E-4340-AFD1-1E466CC03A53}" type="datetimeFigureOut">
              <a:rPr lang="fr-FR" smtClean="0"/>
              <a:t>24/02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79BC1-A1AE-4AD4-A9A6-260F0C11FC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5030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38DCF-C78E-4340-AFD1-1E466CC03A53}" type="datetimeFigureOut">
              <a:rPr lang="fr-FR" smtClean="0"/>
              <a:t>24/0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79BC1-A1AE-4AD4-A9A6-260F0C11FC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8560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38DCF-C78E-4340-AFD1-1E466CC03A53}" type="datetimeFigureOut">
              <a:rPr lang="fr-FR" smtClean="0"/>
              <a:t>24/0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79BC1-A1AE-4AD4-A9A6-260F0C11FC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6445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238DCF-C78E-4340-AFD1-1E466CC03A53}" type="datetimeFigureOut">
              <a:rPr lang="fr-FR" smtClean="0"/>
              <a:t>24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79BC1-A1AE-4AD4-A9A6-260F0C11FC3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53693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llipse 3"/>
          <p:cNvSpPr>
            <a:spLocks noChangeAspect="1"/>
          </p:cNvSpPr>
          <p:nvPr/>
        </p:nvSpPr>
        <p:spPr>
          <a:xfrm>
            <a:off x="3167621" y="2832350"/>
            <a:ext cx="914400" cy="914400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2">
                <a:lumMod val="40000"/>
                <a:lumOff val="6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Ellipse 4"/>
          <p:cNvSpPr>
            <a:spLocks noChangeAspect="1"/>
          </p:cNvSpPr>
          <p:nvPr/>
        </p:nvSpPr>
        <p:spPr>
          <a:xfrm>
            <a:off x="5703165" y="2011075"/>
            <a:ext cx="914400" cy="914400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tx2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Ellipse 5"/>
          <p:cNvSpPr>
            <a:spLocks noChangeAspect="1"/>
          </p:cNvSpPr>
          <p:nvPr/>
        </p:nvSpPr>
        <p:spPr>
          <a:xfrm>
            <a:off x="6664172" y="3843099"/>
            <a:ext cx="914400" cy="9144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6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6593137" y="2190699"/>
            <a:ext cx="17722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>
                <a:latin typeface="Times New Roman" panose="02020603050405020304" pitchFamily="18" charset="0"/>
                <a:cs typeface="Times New Roman" panose="02020603050405020304" pitchFamily="18" charset="0"/>
              </a:rPr>
              <a:t>Hormone-sensitive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7541816" y="4085137"/>
            <a:ext cx="1064301" cy="338554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fr-FR" sz="1600">
                <a:latin typeface="Times New Roman"/>
                <a:cs typeface="Times New Roman"/>
              </a:rPr>
              <a:t>CRPC-NE</a:t>
            </a:r>
            <a:endParaRPr lang="fr-FR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Connecteur droit avec flèche 8"/>
          <p:cNvCxnSpPr/>
          <p:nvPr/>
        </p:nvCxnSpPr>
        <p:spPr>
          <a:xfrm flipV="1">
            <a:off x="1038401" y="3289550"/>
            <a:ext cx="2129220" cy="128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Connecteur droit avec flèche 9"/>
          <p:cNvCxnSpPr>
            <a:cxnSpLocks/>
          </p:cNvCxnSpPr>
          <p:nvPr/>
        </p:nvCxnSpPr>
        <p:spPr>
          <a:xfrm flipV="1">
            <a:off x="4082021" y="2641250"/>
            <a:ext cx="1647648" cy="64958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avec flèche 10"/>
          <p:cNvCxnSpPr/>
          <p:nvPr/>
        </p:nvCxnSpPr>
        <p:spPr>
          <a:xfrm>
            <a:off x="4087911" y="3284894"/>
            <a:ext cx="2622760" cy="80024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ZoneTexte 11"/>
          <p:cNvSpPr txBox="1"/>
          <p:nvPr/>
        </p:nvSpPr>
        <p:spPr>
          <a:xfrm>
            <a:off x="1229763" y="2981773"/>
            <a:ext cx="14460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>
                <a:latin typeface="Times New Roman" panose="02020603050405020304" pitchFamily="18" charset="0"/>
                <a:cs typeface="Times New Roman" panose="02020603050405020304" pitchFamily="18" charset="0"/>
              </a:rPr>
              <a:t>245 mutations</a:t>
            </a:r>
          </a:p>
        </p:txBody>
      </p:sp>
      <p:sp>
        <p:nvSpPr>
          <p:cNvPr id="13" name="ZoneTexte 12"/>
          <p:cNvSpPr txBox="1"/>
          <p:nvPr/>
        </p:nvSpPr>
        <p:spPr>
          <a:xfrm>
            <a:off x="4104258" y="1603540"/>
            <a:ext cx="1731964" cy="116955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1400">
                <a:latin typeface="Times New Roman" panose="02020603050405020304" pitchFamily="18" charset="0"/>
                <a:cs typeface="Times New Roman" panose="02020603050405020304" pitchFamily="18" charset="0"/>
              </a:rPr>
              <a:t>112 mutations</a:t>
            </a:r>
          </a:p>
          <a:p>
            <a:r>
              <a:rPr lang="en-GB" sz="1400" i="1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TRMPRSS2</a:t>
            </a:r>
            <a:r>
              <a:rPr lang="en-GB" sz="140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-</a:t>
            </a:r>
            <a:r>
              <a:rPr lang="en-GB" sz="1400" i="1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ERG </a:t>
            </a:r>
            <a:r>
              <a:rPr lang="en-GB" sz="140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Fusion </a:t>
            </a:r>
            <a:endParaRPr lang="en-GB" sz="1400">
              <a:solidFill>
                <a:schemeClr val="accent6">
                  <a:lumMod val="7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romosomal instability</a:t>
            </a:r>
            <a:endParaRPr lang="en-GB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3990628" y="3771664"/>
            <a:ext cx="14460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>
                <a:latin typeface="Times New Roman" panose="02020603050405020304" pitchFamily="18" charset="0"/>
                <a:cs typeface="Times New Roman" panose="02020603050405020304" pitchFamily="18" charset="0"/>
              </a:rPr>
              <a:t>129 mutations</a:t>
            </a:r>
          </a:p>
        </p:txBody>
      </p:sp>
      <p:sp>
        <p:nvSpPr>
          <p:cNvPr id="15" name="Rectangle 14"/>
          <p:cNvSpPr/>
          <p:nvPr/>
        </p:nvSpPr>
        <p:spPr>
          <a:xfrm>
            <a:off x="997431" y="3376397"/>
            <a:ext cx="2781977" cy="1600438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r>
              <a:rPr lang="en-GB" sz="1400" i="1">
                <a:latin typeface="Times New Roman" panose="02020603050405020304" pitchFamily="18" charset="0"/>
                <a:cs typeface="Times New Roman" panose="02020603050405020304" pitchFamily="18" charset="0"/>
              </a:rPr>
              <a:t>TP53 </a:t>
            </a:r>
            <a:r>
              <a:rPr lang="en-GB" sz="1400">
                <a:latin typeface="Times New Roman" panose="02020603050405020304" pitchFamily="18" charset="0"/>
                <a:cs typeface="Times New Roman" panose="02020603050405020304" pitchFamily="18" charset="0"/>
              </a:rPr>
              <a:t>G334fs (homozygosity)</a:t>
            </a:r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400" i="1">
                <a:latin typeface="Times New Roman" panose="02020603050405020304" pitchFamily="18" charset="0"/>
                <a:cs typeface="Times New Roman" panose="02020603050405020304" pitchFamily="18" charset="0"/>
              </a:rPr>
              <a:t>ARID2 E44D </a:t>
            </a:r>
          </a:p>
          <a:p>
            <a:r>
              <a:rPr lang="en-GB" sz="1400" i="1">
                <a:latin typeface="Times New Roman" panose="02020603050405020304" pitchFamily="18" charset="0"/>
                <a:cs typeface="Times New Roman" panose="02020603050405020304" pitchFamily="18" charset="0"/>
              </a:rPr>
              <a:t>KMT2D K5091R</a:t>
            </a:r>
          </a:p>
          <a:p>
            <a:r>
              <a:rPr lang="en-GB" sz="1400" err="1">
                <a:solidFill>
                  <a:srgbClr val="010AA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del</a:t>
            </a:r>
            <a:r>
              <a:rPr lang="en-GB" sz="1400">
                <a:solidFill>
                  <a:srgbClr val="010AA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i="1">
                <a:solidFill>
                  <a:srgbClr val="010AA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RCA2</a:t>
            </a:r>
          </a:p>
          <a:p>
            <a:r>
              <a:rPr lang="en-GB" sz="1400" err="1">
                <a:solidFill>
                  <a:srgbClr val="010AA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del</a:t>
            </a:r>
            <a:r>
              <a:rPr lang="en-GB" sz="1400">
                <a:solidFill>
                  <a:srgbClr val="010AA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i="1">
                <a:solidFill>
                  <a:srgbClr val="010AA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B1</a:t>
            </a:r>
          </a:p>
          <a:p>
            <a:r>
              <a:rPr lang="en-GB" sz="1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romosomal instability</a:t>
            </a:r>
            <a:endParaRPr lang="en-GB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4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genome duplication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6632EA9-DD55-4DA4-AC0B-E3E13D6B57E6}"/>
              </a:ext>
            </a:extLst>
          </p:cNvPr>
          <p:cNvSpPr/>
          <p:nvPr/>
        </p:nvSpPr>
        <p:spPr>
          <a:xfrm>
            <a:off x="4135431" y="4019698"/>
            <a:ext cx="2585964" cy="1169551"/>
          </a:xfrm>
          <a:prstGeom prst="rect">
            <a:avLst/>
          </a:prstGeom>
        </p:spPr>
        <p:txBody>
          <a:bodyPr wrap="none" lIns="91440" tIns="45720" rIns="91440" bIns="45720" anchor="t">
            <a:spAutoFit/>
          </a:bodyPr>
          <a:lstStyle/>
          <a:p>
            <a:r>
              <a:rPr lang="en-GB" sz="1400" i="1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TRMPRSS2</a:t>
            </a:r>
            <a:r>
              <a:rPr lang="en-GB" sz="1400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-</a:t>
            </a:r>
            <a:r>
              <a:rPr lang="en-GB" sz="1400" i="1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ERG </a:t>
            </a:r>
            <a:r>
              <a:rPr lang="en-GB" sz="1400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Fusion</a:t>
            </a:r>
            <a:endParaRPr lang="en-GB" sz="1400" i="1" dirty="0">
              <a:solidFill>
                <a:schemeClr val="accent6">
                  <a:lumMod val="75000"/>
                </a:schemeClr>
              </a:solidFill>
              <a:latin typeface="Times New Roman" panose="02020603050405020304" pitchFamily="18" charset="0"/>
              <a:ea typeface="+mn-lt"/>
              <a:cs typeface="Times New Roman" panose="02020603050405020304" pitchFamily="18" charset="0"/>
            </a:endParaRPr>
          </a:p>
          <a:p>
            <a:r>
              <a:rPr lang="en-GB" sz="1400" i="1" dirty="0">
                <a:solidFill>
                  <a:schemeClr val="accent6">
                    <a:lumMod val="75000"/>
                  </a:schemeClr>
                </a:solidFill>
                <a:latin typeface="Times New Roman" panose="02020603050405020304" pitchFamily="18" charset="0"/>
                <a:ea typeface="+mn-lt"/>
                <a:cs typeface="Times New Roman" panose="02020603050405020304" pitchFamily="18" charset="0"/>
              </a:rPr>
              <a:t>TRMPRSS2- BCO1 translocation</a:t>
            </a:r>
            <a:endParaRPr lang="en-GB" dirty="0">
              <a:solidFill>
                <a:schemeClr val="accent6">
                  <a:lumMod val="75000"/>
                </a:schemeClr>
              </a:solidFill>
              <a:latin typeface="Times New Roman" panose="02020603050405020304" pitchFamily="18" charset="0"/>
              <a:ea typeface="+mn-lt"/>
              <a:cs typeface="Times New Roman" panose="02020603050405020304" pitchFamily="18" charset="0"/>
            </a:endParaRPr>
          </a:p>
          <a:p>
            <a:r>
              <a:rPr lang="en-GB" sz="14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TV1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441fs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F1L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495E</a:t>
            </a:r>
          </a:p>
          <a:p>
            <a:r>
              <a:rPr lang="en-GB" sz="14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romosomal instability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39DA79F4-7AFB-C141-944B-4484E231B8F3}"/>
              </a:ext>
            </a:extLst>
          </p:cNvPr>
          <p:cNvSpPr txBox="1"/>
          <p:nvPr/>
        </p:nvSpPr>
        <p:spPr>
          <a:xfrm>
            <a:off x="199373" y="3025891"/>
            <a:ext cx="7984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>
                <a:latin typeface="Times New Roman" panose="02020603050405020304" pitchFamily="18" charset="0"/>
                <a:cs typeface="Times New Roman" panose="02020603050405020304" pitchFamily="18" charset="0"/>
              </a:rPr>
              <a:t>Normal </a:t>
            </a:r>
            <a:r>
              <a:rPr lang="fr-FR" sz="140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endParaRPr lang="fr-FR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57DE582E-934C-3748-B767-0C35E72BF1D2}"/>
              </a:ext>
            </a:extLst>
          </p:cNvPr>
          <p:cNvSpPr txBox="1"/>
          <p:nvPr/>
        </p:nvSpPr>
        <p:spPr>
          <a:xfrm>
            <a:off x="3094260" y="3025891"/>
            <a:ext cx="102501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>
                <a:latin typeface="Times New Roman" panose="02020603050405020304" pitchFamily="18" charset="0"/>
                <a:cs typeface="Times New Roman" panose="02020603050405020304" pitchFamily="18" charset="0"/>
              </a:rPr>
              <a:t>Common </a:t>
            </a:r>
            <a:r>
              <a:rPr lang="fr-FR" sz="140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cursor</a:t>
            </a:r>
            <a:endParaRPr lang="fr-FR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2E2FDCBA-F211-4045-8D87-F2FF6A0E9236}"/>
              </a:ext>
            </a:extLst>
          </p:cNvPr>
          <p:cNvSpPr/>
          <p:nvPr/>
        </p:nvSpPr>
        <p:spPr>
          <a:xfrm>
            <a:off x="6731990" y="4131022"/>
            <a:ext cx="73129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>
                <a:latin typeface="Times New Roman" panose="02020603050405020304" pitchFamily="18" charset="0"/>
                <a:cs typeface="Times New Roman" panose="02020603050405020304" pitchFamily="18" charset="0"/>
              </a:rPr>
              <a:t>C1022</a:t>
            </a:r>
            <a:endParaRPr 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6EFC10A4-2C14-114F-9A26-351313039928}"/>
              </a:ext>
            </a:extLst>
          </p:cNvPr>
          <p:cNvSpPr/>
          <p:nvPr/>
        </p:nvSpPr>
        <p:spPr>
          <a:xfrm>
            <a:off x="5845023" y="2286233"/>
            <a:ext cx="62869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>
                <a:latin typeface="Times New Roman" panose="02020603050405020304" pitchFamily="18" charset="0"/>
                <a:cs typeface="Times New Roman" panose="02020603050405020304" pitchFamily="18" charset="0"/>
              </a:rPr>
              <a:t>C901</a:t>
            </a:r>
            <a:endParaRPr 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Ellipse 20"/>
          <p:cNvSpPr>
            <a:spLocks noChangeAspect="1"/>
          </p:cNvSpPr>
          <p:nvPr/>
        </p:nvSpPr>
        <p:spPr>
          <a:xfrm>
            <a:off x="124001" y="2833631"/>
            <a:ext cx="914400" cy="914400"/>
          </a:xfrm>
          <a:prstGeom prst="ellipse">
            <a:avLst/>
          </a:prstGeom>
          <a:noFill/>
          <a:ln>
            <a:solidFill>
              <a:schemeClr val="tx2">
                <a:lumMod val="40000"/>
                <a:lumOff val="6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580577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BFF3963F00EB54E9A3761152733AC6A" ma:contentTypeVersion="4" ma:contentTypeDescription="Create a new document." ma:contentTypeScope="" ma:versionID="e7ffe98eff975e76c50d3452d9430135">
  <xsd:schema xmlns:xsd="http://www.w3.org/2001/XMLSchema" xmlns:xs="http://www.w3.org/2001/XMLSchema" xmlns:p="http://schemas.microsoft.com/office/2006/metadata/properties" xmlns:ns2="b0fabec9-6a62-41a8-94aa-3905766af3d1" xmlns:ns3="e4da75e6-af4f-48ad-8689-e58586a6a97d" targetNamespace="http://schemas.microsoft.com/office/2006/metadata/properties" ma:root="true" ma:fieldsID="b175bc2b261cd1d35f2b535bc3efeb99" ns2:_="" ns3:_="">
    <xsd:import namespace="b0fabec9-6a62-41a8-94aa-3905766af3d1"/>
    <xsd:import namespace="e4da75e6-af4f-48ad-8689-e58586a6a97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0fabec9-6a62-41a8-94aa-3905766af3d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da75e6-af4f-48ad-8689-e58586a6a97d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0508917C-5D70-4CC7-9777-E2F06A636D38}">
  <ds:schemaRefs>
    <ds:schemaRef ds:uri="27c2baea-f839-463b-99f7-34e8163e9fa5"/>
    <ds:schemaRef ds:uri="52a3bd0d-980d-4ae9-be23-344198efd72c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0DAFCE18-3EFB-43A4-BE7E-913590038F1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0fabec9-6a62-41a8-94aa-3905766af3d1"/>
    <ds:schemaRef ds:uri="e4da75e6-af4f-48ad-8689-e58586a6a97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068170AE-AAFF-41FA-82EC-8F192E409F60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7</Words>
  <Application>Microsoft Office PowerPoint</Application>
  <PresentationFormat>Affichage à l'écran (4:3)</PresentationFormat>
  <Paragraphs>2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Yolande Misseri</dc:creator>
  <cp:lastModifiedBy>Nadege Bidan</cp:lastModifiedBy>
  <cp:revision>5</cp:revision>
  <dcterms:created xsi:type="dcterms:W3CDTF">2022-09-05T13:13:18Z</dcterms:created>
  <dcterms:modified xsi:type="dcterms:W3CDTF">2023-02-24T14:33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BFF3963F00EB54E9A3761152733AC6A</vt:lpwstr>
  </property>
  <property fmtid="{D5CDD505-2E9C-101B-9397-08002B2CF9AE}" pid="3" name="MediaServiceImageTags">
    <vt:lpwstr/>
  </property>
</Properties>
</file>